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154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EUROFINS%20NGS\DATA%20FROM%20EUROFINS\ANALYSIS%20for%20PAPER\KEGG%20KAAS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0.35723847019122612"/>
          <c:y val="5.1889443686896859E-2"/>
          <c:w val="0.61312979002624668"/>
          <c:h val="0.8867679271572525"/>
        </c:manualLayout>
      </c:layout>
      <c:barChart>
        <c:barDir val="bar"/>
        <c:grouping val="clustered"/>
        <c:ser>
          <c:idx val="0"/>
          <c:order val="0"/>
          <c:tx>
            <c:strRef>
              <c:f>'FINAL Supplementary'!$H$2</c:f>
              <c:strCache>
                <c:ptCount val="1"/>
                <c:pt idx="0">
                  <c:v>CONTROL</c:v>
                </c:pt>
              </c:strCache>
            </c:strRef>
          </c:tx>
          <c:cat>
            <c:strRef>
              <c:f>'FINAL Supplementary'!$G$3:$G$30</c:f>
              <c:strCache>
                <c:ptCount val="28"/>
                <c:pt idx="0">
                  <c:v>Carbon metabolism</c:v>
                </c:pt>
                <c:pt idx="1">
                  <c:v>2-Oxocarboxylic acid metabolism</c:v>
                </c:pt>
                <c:pt idx="2">
                  <c:v>Fatty acid metabolism</c:v>
                </c:pt>
                <c:pt idx="3">
                  <c:v>Biosynthesis of amino acids</c:v>
                </c:pt>
                <c:pt idx="4">
                  <c:v>Degradation of aromatic compounds</c:v>
                </c:pt>
                <c:pt idx="5">
                  <c:v>Carbohydrate metabolism</c:v>
                </c:pt>
                <c:pt idx="6">
                  <c:v>Energy metabolism</c:v>
                </c:pt>
                <c:pt idx="7">
                  <c:v>Lipid metabolism</c:v>
                </c:pt>
                <c:pt idx="8">
                  <c:v>Nucleotide metabolism</c:v>
                </c:pt>
                <c:pt idx="9">
                  <c:v>Amino acid metabolism</c:v>
                </c:pt>
                <c:pt idx="10">
                  <c:v>Metabolism of other amino acids</c:v>
                </c:pt>
                <c:pt idx="11">
                  <c:v>Glycan biosynthesis and metabolism</c:v>
                </c:pt>
                <c:pt idx="12">
                  <c:v>Metabolism of cofactors and vitamins</c:v>
                </c:pt>
                <c:pt idx="13">
                  <c:v>Metabolism of terpenoids and polyketides</c:v>
                </c:pt>
                <c:pt idx="14">
                  <c:v>Biosynthesis of other secondary metabolites</c:v>
                </c:pt>
                <c:pt idx="15">
                  <c:v>Xenobiotics biodegradation and metabolism</c:v>
                </c:pt>
                <c:pt idx="16">
                  <c:v>Transcription</c:v>
                </c:pt>
                <c:pt idx="17">
                  <c:v>Translation</c:v>
                </c:pt>
                <c:pt idx="18">
                  <c:v>Folding, sorting and degradation</c:v>
                </c:pt>
                <c:pt idx="19">
                  <c:v>Replication and repair</c:v>
                </c:pt>
                <c:pt idx="20">
                  <c:v>Membrane transport</c:v>
                </c:pt>
                <c:pt idx="21">
                  <c:v>Signal transduction</c:v>
                </c:pt>
                <c:pt idx="22">
                  <c:v>Transport and catabolism</c:v>
                </c:pt>
                <c:pt idx="23">
                  <c:v>Cell motility</c:v>
                </c:pt>
                <c:pt idx="24">
                  <c:v>Cell growth and death</c:v>
                </c:pt>
                <c:pt idx="25">
                  <c:v>Cellular community - eukaryotes</c:v>
                </c:pt>
                <c:pt idx="26">
                  <c:v>Cellular community - prokaryotes</c:v>
                </c:pt>
                <c:pt idx="27">
                  <c:v>Environmental adaptation</c:v>
                </c:pt>
              </c:strCache>
            </c:strRef>
          </c:cat>
          <c:val>
            <c:numRef>
              <c:f>'FINAL Supplementary'!$H$3:$H$30</c:f>
              <c:numCache>
                <c:formatCode>General</c:formatCode>
                <c:ptCount val="28"/>
                <c:pt idx="0">
                  <c:v>0.7100591715976331</c:v>
                </c:pt>
                <c:pt idx="1">
                  <c:v>0.13806706114398423</c:v>
                </c:pt>
                <c:pt idx="2">
                  <c:v>0.17011834319526725</c:v>
                </c:pt>
                <c:pt idx="3">
                  <c:v>0.62623274161735476</c:v>
                </c:pt>
                <c:pt idx="4">
                  <c:v>2.7120315581854265E-2</c:v>
                </c:pt>
                <c:pt idx="5">
                  <c:v>2.6454635108481264</c:v>
                </c:pt>
                <c:pt idx="6">
                  <c:v>1.1341222879684418</c:v>
                </c:pt>
                <c:pt idx="7">
                  <c:v>1.2352071005917205</c:v>
                </c:pt>
                <c:pt idx="8">
                  <c:v>0.85798816568047365</c:v>
                </c:pt>
                <c:pt idx="9">
                  <c:v>1.5877712031558178</c:v>
                </c:pt>
                <c:pt idx="10">
                  <c:v>0.53500986193293665</c:v>
                </c:pt>
                <c:pt idx="11">
                  <c:v>0.57692307692308065</c:v>
                </c:pt>
                <c:pt idx="12">
                  <c:v>0.73717948717949155</c:v>
                </c:pt>
                <c:pt idx="13">
                  <c:v>0.48076923076923078</c:v>
                </c:pt>
                <c:pt idx="14">
                  <c:v>0.60650887573964496</c:v>
                </c:pt>
                <c:pt idx="15">
                  <c:v>0.40680473372781289</c:v>
                </c:pt>
                <c:pt idx="16">
                  <c:v>0.8875739644970404</c:v>
                </c:pt>
                <c:pt idx="17">
                  <c:v>2.0586785009861934</c:v>
                </c:pt>
                <c:pt idx="18">
                  <c:v>1.6173570019723906</c:v>
                </c:pt>
                <c:pt idx="19">
                  <c:v>1.0009861932938857</c:v>
                </c:pt>
                <c:pt idx="20">
                  <c:v>0.10355029585798817</c:v>
                </c:pt>
                <c:pt idx="21">
                  <c:v>5.1208086785009632</c:v>
                </c:pt>
                <c:pt idx="22">
                  <c:v>1.3165680473372778</c:v>
                </c:pt>
                <c:pt idx="23">
                  <c:v>0.18984220907297919</c:v>
                </c:pt>
                <c:pt idx="24">
                  <c:v>1.4176528599605522</c:v>
                </c:pt>
                <c:pt idx="25">
                  <c:v>0.39201183431952796</c:v>
                </c:pt>
                <c:pt idx="26">
                  <c:v>0.16765285996055188</c:v>
                </c:pt>
                <c:pt idx="27">
                  <c:v>0.63116370808678501</c:v>
                </c:pt>
              </c:numCache>
            </c:numRef>
          </c:val>
        </c:ser>
        <c:ser>
          <c:idx val="1"/>
          <c:order val="1"/>
          <c:tx>
            <c:strRef>
              <c:f>'FINAL Supplementary'!$I$2</c:f>
              <c:strCache>
                <c:ptCount val="1"/>
                <c:pt idx="0">
                  <c:v>COLD</c:v>
                </c:pt>
              </c:strCache>
            </c:strRef>
          </c:tx>
          <c:cat>
            <c:strRef>
              <c:f>'FINAL Supplementary'!$G$3:$G$30</c:f>
              <c:strCache>
                <c:ptCount val="28"/>
                <c:pt idx="0">
                  <c:v>Carbon metabolism</c:v>
                </c:pt>
                <c:pt idx="1">
                  <c:v>2-Oxocarboxylic acid metabolism</c:v>
                </c:pt>
                <c:pt idx="2">
                  <c:v>Fatty acid metabolism</c:v>
                </c:pt>
                <c:pt idx="3">
                  <c:v>Biosynthesis of amino acids</c:v>
                </c:pt>
                <c:pt idx="4">
                  <c:v>Degradation of aromatic compounds</c:v>
                </c:pt>
                <c:pt idx="5">
                  <c:v>Carbohydrate metabolism</c:v>
                </c:pt>
                <c:pt idx="6">
                  <c:v>Energy metabolism</c:v>
                </c:pt>
                <c:pt idx="7">
                  <c:v>Lipid metabolism</c:v>
                </c:pt>
                <c:pt idx="8">
                  <c:v>Nucleotide metabolism</c:v>
                </c:pt>
                <c:pt idx="9">
                  <c:v>Amino acid metabolism</c:v>
                </c:pt>
                <c:pt idx="10">
                  <c:v>Metabolism of other amino acids</c:v>
                </c:pt>
                <c:pt idx="11">
                  <c:v>Glycan biosynthesis and metabolism</c:v>
                </c:pt>
                <c:pt idx="12">
                  <c:v>Metabolism of cofactors and vitamins</c:v>
                </c:pt>
                <c:pt idx="13">
                  <c:v>Metabolism of terpenoids and polyketides</c:v>
                </c:pt>
                <c:pt idx="14">
                  <c:v>Biosynthesis of other secondary metabolites</c:v>
                </c:pt>
                <c:pt idx="15">
                  <c:v>Xenobiotics biodegradation and metabolism</c:v>
                </c:pt>
                <c:pt idx="16">
                  <c:v>Transcription</c:v>
                </c:pt>
                <c:pt idx="17">
                  <c:v>Translation</c:v>
                </c:pt>
                <c:pt idx="18">
                  <c:v>Folding, sorting and degradation</c:v>
                </c:pt>
                <c:pt idx="19">
                  <c:v>Replication and repair</c:v>
                </c:pt>
                <c:pt idx="20">
                  <c:v>Membrane transport</c:v>
                </c:pt>
                <c:pt idx="21">
                  <c:v>Signal transduction</c:v>
                </c:pt>
                <c:pt idx="22">
                  <c:v>Transport and catabolism</c:v>
                </c:pt>
                <c:pt idx="23">
                  <c:v>Cell motility</c:v>
                </c:pt>
                <c:pt idx="24">
                  <c:v>Cell growth and death</c:v>
                </c:pt>
                <c:pt idx="25">
                  <c:v>Cellular community - eukaryotes</c:v>
                </c:pt>
                <c:pt idx="26">
                  <c:v>Cellular community - prokaryotes</c:v>
                </c:pt>
                <c:pt idx="27">
                  <c:v>Environmental adaptation</c:v>
                </c:pt>
              </c:strCache>
            </c:strRef>
          </c:cat>
          <c:val>
            <c:numRef>
              <c:f>'FINAL Supplementary'!$I$3:$I$30</c:f>
              <c:numCache>
                <c:formatCode>General</c:formatCode>
                <c:ptCount val="28"/>
                <c:pt idx="0">
                  <c:v>0.78824356114998007</c:v>
                </c:pt>
                <c:pt idx="1">
                  <c:v>0.12831871925697352</c:v>
                </c:pt>
                <c:pt idx="2">
                  <c:v>0.17414683327732219</c:v>
                </c:pt>
                <c:pt idx="3">
                  <c:v>0.65992484189300904</c:v>
                </c:pt>
                <c:pt idx="4">
                  <c:v>1.8331245608139129E-2</c:v>
                </c:pt>
                <c:pt idx="5">
                  <c:v>2.8077357856466412</c:v>
                </c:pt>
                <c:pt idx="6">
                  <c:v>1.298463230576518</c:v>
                </c:pt>
                <c:pt idx="7">
                  <c:v>1.4145611194280652</c:v>
                </c:pt>
                <c:pt idx="8">
                  <c:v>0.80657480675812065</c:v>
                </c:pt>
                <c:pt idx="9">
                  <c:v>1.6498121047325216</c:v>
                </c:pt>
                <c:pt idx="10">
                  <c:v>0.56521340625095451</c:v>
                </c:pt>
                <c:pt idx="11">
                  <c:v>0.62326235067672853</c:v>
                </c:pt>
                <c:pt idx="12">
                  <c:v>0.74547065473098895</c:v>
                </c:pt>
                <c:pt idx="13">
                  <c:v>0.5346613302373896</c:v>
                </c:pt>
                <c:pt idx="14">
                  <c:v>0.62326235067672853</c:v>
                </c:pt>
                <c:pt idx="15">
                  <c:v>0.40939781858177265</c:v>
                </c:pt>
                <c:pt idx="16">
                  <c:v>1.0021080932449358</c:v>
                </c:pt>
                <c:pt idx="17">
                  <c:v>2.428890043078427</c:v>
                </c:pt>
                <c:pt idx="18">
                  <c:v>1.9156151660505361</c:v>
                </c:pt>
                <c:pt idx="19">
                  <c:v>0.91350707280559762</c:v>
                </c:pt>
                <c:pt idx="20">
                  <c:v>9.1656228040695883E-2</c:v>
                </c:pt>
                <c:pt idx="21">
                  <c:v>5.6154715712932655</c:v>
                </c:pt>
                <c:pt idx="22">
                  <c:v>1.5642662918945338</c:v>
                </c:pt>
                <c:pt idx="23">
                  <c:v>0.13748434206104376</c:v>
                </c:pt>
                <c:pt idx="24">
                  <c:v>1.3015184381778742</c:v>
                </c:pt>
                <c:pt idx="25">
                  <c:v>0.34218325135193001</c:v>
                </c:pt>
                <c:pt idx="26">
                  <c:v>0.14359475726375587</c:v>
                </c:pt>
                <c:pt idx="27">
                  <c:v>0.86462375118389734</c:v>
                </c:pt>
              </c:numCache>
            </c:numRef>
          </c:val>
        </c:ser>
        <c:ser>
          <c:idx val="2"/>
          <c:order val="2"/>
          <c:tx>
            <c:strRef>
              <c:f>'FINAL Supplementary'!$J$2</c:f>
              <c:strCache>
                <c:ptCount val="1"/>
                <c:pt idx="0">
                  <c:v>FLOOD</c:v>
                </c:pt>
              </c:strCache>
            </c:strRef>
          </c:tx>
          <c:cat>
            <c:strRef>
              <c:f>'FINAL Supplementary'!$G$3:$G$30</c:f>
              <c:strCache>
                <c:ptCount val="28"/>
                <c:pt idx="0">
                  <c:v>Carbon metabolism</c:v>
                </c:pt>
                <c:pt idx="1">
                  <c:v>2-Oxocarboxylic acid metabolism</c:v>
                </c:pt>
                <c:pt idx="2">
                  <c:v>Fatty acid metabolism</c:v>
                </c:pt>
                <c:pt idx="3">
                  <c:v>Biosynthesis of amino acids</c:v>
                </c:pt>
                <c:pt idx="4">
                  <c:v>Degradation of aromatic compounds</c:v>
                </c:pt>
                <c:pt idx="5">
                  <c:v>Carbohydrate metabolism</c:v>
                </c:pt>
                <c:pt idx="6">
                  <c:v>Energy metabolism</c:v>
                </c:pt>
                <c:pt idx="7">
                  <c:v>Lipid metabolism</c:v>
                </c:pt>
                <c:pt idx="8">
                  <c:v>Nucleotide metabolism</c:v>
                </c:pt>
                <c:pt idx="9">
                  <c:v>Amino acid metabolism</c:v>
                </c:pt>
                <c:pt idx="10">
                  <c:v>Metabolism of other amino acids</c:v>
                </c:pt>
                <c:pt idx="11">
                  <c:v>Glycan biosynthesis and metabolism</c:v>
                </c:pt>
                <c:pt idx="12">
                  <c:v>Metabolism of cofactors and vitamins</c:v>
                </c:pt>
                <c:pt idx="13">
                  <c:v>Metabolism of terpenoids and polyketides</c:v>
                </c:pt>
                <c:pt idx="14">
                  <c:v>Biosynthesis of other secondary metabolites</c:v>
                </c:pt>
                <c:pt idx="15">
                  <c:v>Xenobiotics biodegradation and metabolism</c:v>
                </c:pt>
                <c:pt idx="16">
                  <c:v>Transcription</c:v>
                </c:pt>
                <c:pt idx="17">
                  <c:v>Translation</c:v>
                </c:pt>
                <c:pt idx="18">
                  <c:v>Folding, sorting and degradation</c:v>
                </c:pt>
                <c:pt idx="19">
                  <c:v>Replication and repair</c:v>
                </c:pt>
                <c:pt idx="20">
                  <c:v>Membrane transport</c:v>
                </c:pt>
                <c:pt idx="21">
                  <c:v>Signal transduction</c:v>
                </c:pt>
                <c:pt idx="22">
                  <c:v>Transport and catabolism</c:v>
                </c:pt>
                <c:pt idx="23">
                  <c:v>Cell motility</c:v>
                </c:pt>
                <c:pt idx="24">
                  <c:v>Cell growth and death</c:v>
                </c:pt>
                <c:pt idx="25">
                  <c:v>Cellular community - eukaryotes</c:v>
                </c:pt>
                <c:pt idx="26">
                  <c:v>Cellular community - prokaryotes</c:v>
                </c:pt>
                <c:pt idx="27">
                  <c:v>Environmental adaptation</c:v>
                </c:pt>
              </c:strCache>
            </c:strRef>
          </c:cat>
          <c:val>
            <c:numRef>
              <c:f>'FINAL Supplementary'!$J$3:$J$30</c:f>
              <c:numCache>
                <c:formatCode>General</c:formatCode>
                <c:ptCount val="28"/>
                <c:pt idx="0">
                  <c:v>0.77633477633477865</c:v>
                </c:pt>
                <c:pt idx="1">
                  <c:v>0.13564213564213626</c:v>
                </c:pt>
                <c:pt idx="2">
                  <c:v>0.17604617604617662</c:v>
                </c:pt>
                <c:pt idx="3">
                  <c:v>0.66666666666666674</c:v>
                </c:pt>
                <c:pt idx="4">
                  <c:v>2.886002886002887E-2</c:v>
                </c:pt>
                <c:pt idx="5">
                  <c:v>2.9004329004329006</c:v>
                </c:pt>
                <c:pt idx="6">
                  <c:v>1.22943722943723</c:v>
                </c:pt>
                <c:pt idx="7">
                  <c:v>1.3910533910533911</c:v>
                </c:pt>
                <c:pt idx="8">
                  <c:v>0.85714285714285765</c:v>
                </c:pt>
                <c:pt idx="9">
                  <c:v>1.7604617604617643</c:v>
                </c:pt>
                <c:pt idx="10">
                  <c:v>0.53679653679653683</c:v>
                </c:pt>
                <c:pt idx="11">
                  <c:v>0.5829725829725827</c:v>
                </c:pt>
                <c:pt idx="12">
                  <c:v>0.7561327561327561</c:v>
                </c:pt>
                <c:pt idx="13">
                  <c:v>0.54545454545454553</c:v>
                </c:pt>
                <c:pt idx="14">
                  <c:v>0.64646464646464663</c:v>
                </c:pt>
                <c:pt idx="15">
                  <c:v>0.42135642135642315</c:v>
                </c:pt>
                <c:pt idx="16">
                  <c:v>0.9898989898989895</c:v>
                </c:pt>
                <c:pt idx="17">
                  <c:v>2.3001443001443</c:v>
                </c:pt>
                <c:pt idx="18">
                  <c:v>1.9393939393939399</c:v>
                </c:pt>
                <c:pt idx="19">
                  <c:v>1.0649350649350691</c:v>
                </c:pt>
                <c:pt idx="20">
                  <c:v>0.11832611832611874</c:v>
                </c:pt>
                <c:pt idx="21">
                  <c:v>5.2380952380952355</c:v>
                </c:pt>
                <c:pt idx="22">
                  <c:v>1.4430014430014391</c:v>
                </c:pt>
                <c:pt idx="23">
                  <c:v>0.19624819624819712</c:v>
                </c:pt>
                <c:pt idx="24">
                  <c:v>1.4660894660894659</c:v>
                </c:pt>
                <c:pt idx="25">
                  <c:v>0.34632034632034819</c:v>
                </c:pt>
                <c:pt idx="26">
                  <c:v>0.18181818181818263</c:v>
                </c:pt>
                <c:pt idx="27">
                  <c:v>0.74170274170273942</c:v>
                </c:pt>
              </c:numCache>
            </c:numRef>
          </c:val>
        </c:ser>
        <c:ser>
          <c:idx val="3"/>
          <c:order val="3"/>
          <c:tx>
            <c:strRef>
              <c:f>'FINAL Supplementary'!$K$2</c:f>
              <c:strCache>
                <c:ptCount val="1"/>
                <c:pt idx="0">
                  <c:v>DROUGHT</c:v>
                </c:pt>
              </c:strCache>
            </c:strRef>
          </c:tx>
          <c:cat>
            <c:strRef>
              <c:f>'FINAL Supplementary'!$G$3:$G$30</c:f>
              <c:strCache>
                <c:ptCount val="28"/>
                <c:pt idx="0">
                  <c:v>Carbon metabolism</c:v>
                </c:pt>
                <c:pt idx="1">
                  <c:v>2-Oxocarboxylic acid metabolism</c:v>
                </c:pt>
                <c:pt idx="2">
                  <c:v>Fatty acid metabolism</c:v>
                </c:pt>
                <c:pt idx="3">
                  <c:v>Biosynthesis of amino acids</c:v>
                </c:pt>
                <c:pt idx="4">
                  <c:v>Degradation of aromatic compounds</c:v>
                </c:pt>
                <c:pt idx="5">
                  <c:v>Carbohydrate metabolism</c:v>
                </c:pt>
                <c:pt idx="6">
                  <c:v>Energy metabolism</c:v>
                </c:pt>
                <c:pt idx="7">
                  <c:v>Lipid metabolism</c:v>
                </c:pt>
                <c:pt idx="8">
                  <c:v>Nucleotide metabolism</c:v>
                </c:pt>
                <c:pt idx="9">
                  <c:v>Amino acid metabolism</c:v>
                </c:pt>
                <c:pt idx="10">
                  <c:v>Metabolism of other amino acids</c:v>
                </c:pt>
                <c:pt idx="11">
                  <c:v>Glycan biosynthesis and metabolism</c:v>
                </c:pt>
                <c:pt idx="12">
                  <c:v>Metabolism of cofactors and vitamins</c:v>
                </c:pt>
                <c:pt idx="13">
                  <c:v>Metabolism of terpenoids and polyketides</c:v>
                </c:pt>
                <c:pt idx="14">
                  <c:v>Biosynthesis of other secondary metabolites</c:v>
                </c:pt>
                <c:pt idx="15">
                  <c:v>Xenobiotics biodegradation and metabolism</c:v>
                </c:pt>
                <c:pt idx="16">
                  <c:v>Transcription</c:v>
                </c:pt>
                <c:pt idx="17">
                  <c:v>Translation</c:v>
                </c:pt>
                <c:pt idx="18">
                  <c:v>Folding, sorting and degradation</c:v>
                </c:pt>
                <c:pt idx="19">
                  <c:v>Replication and repair</c:v>
                </c:pt>
                <c:pt idx="20">
                  <c:v>Membrane transport</c:v>
                </c:pt>
                <c:pt idx="21">
                  <c:v>Signal transduction</c:v>
                </c:pt>
                <c:pt idx="22">
                  <c:v>Transport and catabolism</c:v>
                </c:pt>
                <c:pt idx="23">
                  <c:v>Cell motility</c:v>
                </c:pt>
                <c:pt idx="24">
                  <c:v>Cell growth and death</c:v>
                </c:pt>
                <c:pt idx="25">
                  <c:v>Cellular community - eukaryotes</c:v>
                </c:pt>
                <c:pt idx="26">
                  <c:v>Cellular community - prokaryotes</c:v>
                </c:pt>
                <c:pt idx="27">
                  <c:v>Environmental adaptation</c:v>
                </c:pt>
              </c:strCache>
            </c:strRef>
          </c:cat>
          <c:val>
            <c:numRef>
              <c:f>'FINAL Supplementary'!$K$3:$K$30</c:f>
              <c:numCache>
                <c:formatCode>General</c:formatCode>
                <c:ptCount val="28"/>
                <c:pt idx="0">
                  <c:v>0.64653991562106183</c:v>
                </c:pt>
                <c:pt idx="1">
                  <c:v>0.13423921976877978</c:v>
                </c:pt>
                <c:pt idx="2">
                  <c:v>0.13697879568242913</c:v>
                </c:pt>
                <c:pt idx="3">
                  <c:v>0.58626924552079362</c:v>
                </c:pt>
                <c:pt idx="4">
                  <c:v>1.9177031395539983E-2</c:v>
                </c:pt>
                <c:pt idx="5">
                  <c:v>2.2519314010191231</c:v>
                </c:pt>
                <c:pt idx="6">
                  <c:v>1.101309517286724</c:v>
                </c:pt>
                <c:pt idx="7">
                  <c:v>0.95611199386334988</c:v>
                </c:pt>
                <c:pt idx="8">
                  <c:v>0.72324804120322173</c:v>
                </c:pt>
                <c:pt idx="9">
                  <c:v>1.3971837159607701</c:v>
                </c:pt>
                <c:pt idx="10">
                  <c:v>0.42463426661552794</c:v>
                </c:pt>
                <c:pt idx="11">
                  <c:v>0.41915511478823075</c:v>
                </c:pt>
                <c:pt idx="12">
                  <c:v>0.63558161196646767</c:v>
                </c:pt>
                <c:pt idx="13">
                  <c:v>0.37258232425620647</c:v>
                </c:pt>
                <c:pt idx="14">
                  <c:v>0.44381129801106844</c:v>
                </c:pt>
                <c:pt idx="15">
                  <c:v>0.31231165415593681</c:v>
                </c:pt>
                <c:pt idx="16">
                  <c:v>0.70955016163497886</c:v>
                </c:pt>
                <c:pt idx="17">
                  <c:v>1.8848282285902143</c:v>
                </c:pt>
                <c:pt idx="18">
                  <c:v>1.446496082406439</c:v>
                </c:pt>
                <c:pt idx="19">
                  <c:v>0.80543531861267881</c:v>
                </c:pt>
                <c:pt idx="20">
                  <c:v>6.5749821927565857E-2</c:v>
                </c:pt>
                <c:pt idx="21">
                  <c:v>3.2847515204646411</c:v>
                </c:pt>
                <c:pt idx="22">
                  <c:v>1.0684346063229373</c:v>
                </c:pt>
                <c:pt idx="23">
                  <c:v>0.12328091611418551</c:v>
                </c:pt>
                <c:pt idx="24">
                  <c:v>1.1917155224371281</c:v>
                </c:pt>
                <c:pt idx="25">
                  <c:v>0.35340529286066646</c:v>
                </c:pt>
                <c:pt idx="26">
                  <c:v>0.19450988986904877</c:v>
                </c:pt>
                <c:pt idx="27">
                  <c:v>0.42737384252917648</c:v>
                </c:pt>
              </c:numCache>
            </c:numRef>
          </c:val>
        </c:ser>
        <c:ser>
          <c:idx val="4"/>
          <c:order val="4"/>
          <c:tx>
            <c:strRef>
              <c:f>'FINAL Supplementary'!$L$2</c:f>
              <c:strCache>
                <c:ptCount val="1"/>
                <c:pt idx="0">
                  <c:v>SALT</c:v>
                </c:pt>
              </c:strCache>
            </c:strRef>
          </c:tx>
          <c:cat>
            <c:strRef>
              <c:f>'FINAL Supplementary'!$G$3:$G$30</c:f>
              <c:strCache>
                <c:ptCount val="28"/>
                <c:pt idx="0">
                  <c:v>Carbon metabolism</c:v>
                </c:pt>
                <c:pt idx="1">
                  <c:v>2-Oxocarboxylic acid metabolism</c:v>
                </c:pt>
                <c:pt idx="2">
                  <c:v>Fatty acid metabolism</c:v>
                </c:pt>
                <c:pt idx="3">
                  <c:v>Biosynthesis of amino acids</c:v>
                </c:pt>
                <c:pt idx="4">
                  <c:v>Degradation of aromatic compounds</c:v>
                </c:pt>
                <c:pt idx="5">
                  <c:v>Carbohydrate metabolism</c:v>
                </c:pt>
                <c:pt idx="6">
                  <c:v>Energy metabolism</c:v>
                </c:pt>
                <c:pt idx="7">
                  <c:v>Lipid metabolism</c:v>
                </c:pt>
                <c:pt idx="8">
                  <c:v>Nucleotide metabolism</c:v>
                </c:pt>
                <c:pt idx="9">
                  <c:v>Amino acid metabolism</c:v>
                </c:pt>
                <c:pt idx="10">
                  <c:v>Metabolism of other amino acids</c:v>
                </c:pt>
                <c:pt idx="11">
                  <c:v>Glycan biosynthesis and metabolism</c:v>
                </c:pt>
                <c:pt idx="12">
                  <c:v>Metabolism of cofactors and vitamins</c:v>
                </c:pt>
                <c:pt idx="13">
                  <c:v>Metabolism of terpenoids and polyketides</c:v>
                </c:pt>
                <c:pt idx="14">
                  <c:v>Biosynthesis of other secondary metabolites</c:v>
                </c:pt>
                <c:pt idx="15">
                  <c:v>Xenobiotics biodegradation and metabolism</c:v>
                </c:pt>
                <c:pt idx="16">
                  <c:v>Transcription</c:v>
                </c:pt>
                <c:pt idx="17">
                  <c:v>Translation</c:v>
                </c:pt>
                <c:pt idx="18">
                  <c:v>Folding, sorting and degradation</c:v>
                </c:pt>
                <c:pt idx="19">
                  <c:v>Replication and repair</c:v>
                </c:pt>
                <c:pt idx="20">
                  <c:v>Membrane transport</c:v>
                </c:pt>
                <c:pt idx="21">
                  <c:v>Signal transduction</c:v>
                </c:pt>
                <c:pt idx="22">
                  <c:v>Transport and catabolism</c:v>
                </c:pt>
                <c:pt idx="23">
                  <c:v>Cell motility</c:v>
                </c:pt>
                <c:pt idx="24">
                  <c:v>Cell growth and death</c:v>
                </c:pt>
                <c:pt idx="25">
                  <c:v>Cellular community - eukaryotes</c:v>
                </c:pt>
                <c:pt idx="26">
                  <c:v>Cellular community - prokaryotes</c:v>
                </c:pt>
                <c:pt idx="27">
                  <c:v>Environmental adaptation</c:v>
                </c:pt>
              </c:strCache>
            </c:strRef>
          </c:cat>
          <c:val>
            <c:numRef>
              <c:f>'FINAL Supplementary'!$L$3:$L$30</c:f>
              <c:numCache>
                <c:formatCode>General</c:formatCode>
                <c:ptCount val="28"/>
                <c:pt idx="0">
                  <c:v>0.75869260364604241</c:v>
                </c:pt>
                <c:pt idx="1">
                  <c:v>0.16899787853727066</c:v>
                </c:pt>
                <c:pt idx="2">
                  <c:v>0.17978497716730854</c:v>
                </c:pt>
                <c:pt idx="3">
                  <c:v>0.70116141095250084</c:v>
                </c:pt>
                <c:pt idx="4">
                  <c:v>1.7978497716730848E-2</c:v>
                </c:pt>
                <c:pt idx="5">
                  <c:v>2.6068821689259645</c:v>
                </c:pt>
                <c:pt idx="6">
                  <c:v>1.30164323469131</c:v>
                </c:pt>
                <c:pt idx="7">
                  <c:v>1.1542195534141166</c:v>
                </c:pt>
                <c:pt idx="8">
                  <c:v>0.77667110136277162</c:v>
                </c:pt>
                <c:pt idx="9">
                  <c:v>1.5964905972456938</c:v>
                </c:pt>
                <c:pt idx="10">
                  <c:v>0.47463233972169289</c:v>
                </c:pt>
                <c:pt idx="11">
                  <c:v>0.55373772967530832</c:v>
                </c:pt>
                <c:pt idx="12">
                  <c:v>0.72633130775592358</c:v>
                </c:pt>
                <c:pt idx="13">
                  <c:v>0.46024954154830705</c:v>
                </c:pt>
                <c:pt idx="14">
                  <c:v>0.47463233972169289</c:v>
                </c:pt>
                <c:pt idx="15">
                  <c:v>0.37035705296465604</c:v>
                </c:pt>
                <c:pt idx="16">
                  <c:v>0.86296789040308153</c:v>
                </c:pt>
                <c:pt idx="17">
                  <c:v>2.3120348063715794</c:v>
                </c:pt>
                <c:pt idx="18">
                  <c:v>1.6504260903958858</c:v>
                </c:pt>
                <c:pt idx="19">
                  <c:v>0.78026680090611433</c:v>
                </c:pt>
                <c:pt idx="20">
                  <c:v>7.5509690410269323E-2</c:v>
                </c:pt>
                <c:pt idx="21">
                  <c:v>3.2972564812484269</c:v>
                </c:pt>
                <c:pt idx="22">
                  <c:v>1.2836647369745744</c:v>
                </c:pt>
                <c:pt idx="23">
                  <c:v>0.1294451835604632</c:v>
                </c:pt>
                <c:pt idx="24">
                  <c:v>1.0787098630038481</c:v>
                </c:pt>
                <c:pt idx="25">
                  <c:v>0.29484736255438498</c:v>
                </c:pt>
                <c:pt idx="26">
                  <c:v>0.19416777534069254</c:v>
                </c:pt>
                <c:pt idx="27">
                  <c:v>0.49261083743842382</c:v>
                </c:pt>
              </c:numCache>
            </c:numRef>
          </c:val>
        </c:ser>
        <c:gapWidth val="75"/>
        <c:axId val="62534016"/>
        <c:axId val="62535552"/>
      </c:barChart>
      <c:catAx>
        <c:axId val="62534016"/>
        <c:scaling>
          <c:orientation val="minMax"/>
        </c:scaling>
        <c:axPos val="l"/>
        <c:majorTickMark val="none"/>
        <c:tickLblPos val="nextTo"/>
        <c:txPr>
          <a:bodyPr/>
          <a:lstStyle/>
          <a:p>
            <a:pPr>
              <a:defRPr sz="9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2535552"/>
        <c:crosses val="autoZero"/>
        <c:auto val="1"/>
        <c:lblAlgn val="ctr"/>
        <c:lblOffset val="100"/>
      </c:catAx>
      <c:valAx>
        <c:axId val="6253555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900">
                    <a:latin typeface="Arial" pitchFamily="34" charset="0"/>
                    <a:cs typeface="Arial" pitchFamily="34" charset="0"/>
                  </a:defRPr>
                </a:pPr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Percent of the total coding</a:t>
                </a:r>
                <a:r>
                  <a:rPr lang="en-US" sz="900" baseline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900" baseline="0" dirty="0" smtClean="0">
                    <a:latin typeface="Arial" pitchFamily="34" charset="0"/>
                    <a:cs typeface="Arial" pitchFamily="34" charset="0"/>
                  </a:rPr>
                  <a:t>sequences </a:t>
                </a:r>
                <a:r>
                  <a:rPr lang="en-US" sz="900" baseline="0" dirty="0">
                    <a:latin typeface="Arial" pitchFamily="34" charset="0"/>
                    <a:cs typeface="Arial" pitchFamily="34" charset="0"/>
                  </a:rPr>
                  <a:t>(CDS)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c:rich>
          </c:tx>
          <c:layout/>
        </c:title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2534016"/>
        <c:crosses val="autoZero"/>
        <c:crossBetween val="between"/>
      </c:valAx>
      <c:spPr>
        <a:ln w="25400">
          <a:solidFill>
            <a:schemeClr val="tx1"/>
          </a:solidFill>
        </a:ln>
      </c:spPr>
    </c:plotArea>
    <c:legend>
      <c:legendPos val="b"/>
      <c:layout>
        <c:manualLayout>
          <c:xMode val="edge"/>
          <c:yMode val="edge"/>
          <c:x val="0.3587956692913386"/>
          <c:y val="7.6807390506346378E-3"/>
          <c:w val="0.61074186351706317"/>
          <c:h val="3.3492584126271298E-2"/>
        </c:manualLayout>
      </c:layout>
      <c:txPr>
        <a:bodyPr/>
        <a:lstStyle/>
        <a:p>
          <a:pPr>
            <a:defRPr sz="9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EA7668-8064-4F64-9B5B-0D0340C6B82F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9BD35C-ABA8-4309-B45C-360E32DB5CF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3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KEGG pathway distribution of CDSs in all the four abiotic stress samples and control.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463FBD-3AE8-4879-A93E-F14CD0118E8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C15DA-2E65-474C-9AC5-2088F2D8BCA6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9D1BE-F2D6-4224-9ED1-2094F3C5177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1"/>
          <p:cNvGrpSpPr/>
          <p:nvPr/>
        </p:nvGrpSpPr>
        <p:grpSpPr>
          <a:xfrm>
            <a:off x="3779520" y="744081"/>
            <a:ext cx="4754880" cy="5504319"/>
            <a:chOff x="3779520" y="744081"/>
            <a:chExt cx="4754880" cy="5504319"/>
          </a:xfrm>
        </p:grpSpPr>
        <p:sp>
          <p:nvSpPr>
            <p:cNvPr id="11" name="Rectangle 10"/>
            <p:cNvSpPr/>
            <p:nvPr/>
          </p:nvSpPr>
          <p:spPr>
            <a:xfrm>
              <a:off x="3794760" y="3124200"/>
              <a:ext cx="4663440" cy="3124200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3794760" y="2209800"/>
              <a:ext cx="4663440" cy="914400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>
              <a:off x="3794760" y="1752600"/>
              <a:ext cx="4663440" cy="457200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3779520" y="975360"/>
              <a:ext cx="4678680" cy="77724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6492240" y="4419600"/>
              <a:ext cx="1905000" cy="2769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METABOLISM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492240" y="2438400"/>
              <a:ext cx="1905000" cy="46166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GENETIC INFORMATION AND PROCESSING</a:t>
              </a:r>
              <a:endParaRPr lang="en-US" sz="1200" b="1" dirty="0">
                <a:solidFill>
                  <a:srgbClr val="000000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553200" y="1143001"/>
              <a:ext cx="1828800" cy="2769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CELLULAR PROCESSES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53200" y="744081"/>
              <a:ext cx="1828800" cy="2769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ORGANISMAL SYSTEMS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334000" y="1722120"/>
              <a:ext cx="3200400" cy="2769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ENVIRONMENTAL INFORMATION PROCESSING</a:t>
              </a:r>
              <a:endParaRPr lang="en-US" sz="1200" b="1" dirty="0"/>
            </a:p>
          </p:txBody>
        </p:sp>
      </p:grpSp>
      <p:graphicFrame>
        <p:nvGraphicFramePr>
          <p:cNvPr id="14" name="Chart 13"/>
          <p:cNvGraphicFramePr/>
          <p:nvPr/>
        </p:nvGraphicFramePr>
        <p:xfrm>
          <a:off x="1066800" y="457200"/>
          <a:ext cx="7620000" cy="617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Rectangle 12"/>
          <p:cNvSpPr/>
          <p:nvPr/>
        </p:nvSpPr>
        <p:spPr>
          <a:xfrm>
            <a:off x="0" y="1"/>
            <a:ext cx="9144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S3 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KEGG pathway distribution of CDSs in all the four abiotic stress samples and control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ubhra</dc:creator>
  <cp:lastModifiedBy>Shubhra</cp:lastModifiedBy>
  <cp:revision>9</cp:revision>
  <dcterms:created xsi:type="dcterms:W3CDTF">2017-09-14T06:01:03Z</dcterms:created>
  <dcterms:modified xsi:type="dcterms:W3CDTF">2018-10-02T07:24:22Z</dcterms:modified>
</cp:coreProperties>
</file>